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8"/>
  </p:normalViewPr>
  <p:slideViewPr>
    <p:cSldViewPr snapToGrid="0">
      <p:cViewPr>
        <p:scale>
          <a:sx n="100" d="100"/>
          <a:sy n="100" d="100"/>
        </p:scale>
        <p:origin x="1000" y="5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BD81F7A-A696-3C0E-8B9B-777A1E1A73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8B03C1B2-1C15-D8B3-EC2E-45D0F24969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BD50752-E943-82F8-D5BE-5EC2668DBB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B7250-3C52-DD47-ABB0-447B6FB6FEBD}" type="datetimeFigureOut">
              <a:rPr lang="it-IT" smtClean="0"/>
              <a:t>12/10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081C551-D4F1-A79E-03E3-3F42D44AA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250521B-17AF-A0C3-C15F-BB1797850D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FDA08-FEF8-4C4A-94DD-128D2DD817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75175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F54552D-CA96-0C82-759E-9C5D795248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59ADDE4-DBE8-05E6-16E7-76CA31D1AA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C31620A-3F96-ADE3-49DF-F6DA7167F8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B7250-3C52-DD47-ABB0-447B6FB6FEBD}" type="datetimeFigureOut">
              <a:rPr lang="it-IT" smtClean="0"/>
              <a:t>12/10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8544B9A-50C6-08FE-96A9-25174C1694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607724C-3AE3-34D0-6191-9072401D8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FDA08-FEF8-4C4A-94DD-128D2DD817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74677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27FA5958-1073-C9F0-8158-65B1626F18C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48713C0-7B7D-816D-5CFA-654B868B4C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636CD0B-D576-0165-7EE5-DC0A01A555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B7250-3C52-DD47-ABB0-447B6FB6FEBD}" type="datetimeFigureOut">
              <a:rPr lang="it-IT" smtClean="0"/>
              <a:t>12/10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FF293AD-F30B-C796-89C9-E71F1C99EF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5EAE03B-000E-C6BD-F64C-32FC0FD759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FDA08-FEF8-4C4A-94DD-128D2DD817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3246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33667C5-9567-1A5E-B9A1-4FA2826531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289BDFB-7EC8-5909-AED4-DFEC0CADCF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3499752-8620-1539-3023-5A3AB9589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B7250-3C52-DD47-ABB0-447B6FB6FEBD}" type="datetimeFigureOut">
              <a:rPr lang="it-IT" smtClean="0"/>
              <a:t>12/10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EA9BFD9-028B-D5F1-AEBC-B32A0B2999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51F1F5D-FD49-2339-B1E5-108114E993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FDA08-FEF8-4C4A-94DD-128D2DD817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580477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31474CF-774D-6944-BEAB-65BF7AED37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E11AD17-3895-2F3A-5807-5B57CD018E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DDAE0AD-6FBE-33C1-C664-5CDAD0006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B7250-3C52-DD47-ABB0-447B6FB6FEBD}" type="datetimeFigureOut">
              <a:rPr lang="it-IT" smtClean="0"/>
              <a:t>12/10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BBA5FD4-47FB-7F10-F41E-3DB6445CD8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90273E9-530E-C97E-6982-1F4563D51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FDA08-FEF8-4C4A-94DD-128D2DD817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07866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B6E959D-680E-BEE1-50DF-B31F33FC43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EEEB00E-B5FD-CC24-2C23-6CAA00C731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78A9D56-0BF7-5B01-35F1-D514C95D55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2A0D13C-3277-A10E-4F85-676D6D17AF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B7250-3C52-DD47-ABB0-447B6FB6FEBD}" type="datetimeFigureOut">
              <a:rPr lang="it-IT" smtClean="0"/>
              <a:t>12/10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A7F5D53-961B-E30E-9AA5-04C02BAC59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819F933-8443-1ECD-D151-DDE560164E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FDA08-FEF8-4C4A-94DD-128D2DD817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585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97356FF-6C7C-A9DF-E610-A099D8276B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64B42D4-BC35-E759-208F-C2D0E772F0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BEB04DE-9547-B1E9-87BF-BF0D1BAB14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082C20D3-CD0D-2486-8C05-C0323D50CA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347D451D-9CCC-9762-4E0B-665DE16A0ED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CE125CA8-F553-188F-EB48-B16D781526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B7250-3C52-DD47-ABB0-447B6FB6FEBD}" type="datetimeFigureOut">
              <a:rPr lang="it-IT" smtClean="0"/>
              <a:t>12/10/22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AC52C5B0-45EF-08B0-41A0-66F703E3A8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D777631A-6816-9FFB-0EF5-DEDC3AC86A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FDA08-FEF8-4C4A-94DD-128D2DD817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4488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E6D14E6-F978-5A8E-F6D8-EE6F330F02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92163E45-FAE4-BA68-1D0E-5B03FA73B8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B7250-3C52-DD47-ABB0-447B6FB6FEBD}" type="datetimeFigureOut">
              <a:rPr lang="it-IT" smtClean="0"/>
              <a:t>12/10/22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CB147172-4E40-9F3D-C294-77854FBE70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BECA83B3-6046-E3A0-D7EF-940808D8D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FDA08-FEF8-4C4A-94DD-128D2DD817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96999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BD34653D-9545-7373-45D0-4FA6768F30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B7250-3C52-DD47-ABB0-447B6FB6FEBD}" type="datetimeFigureOut">
              <a:rPr lang="it-IT" smtClean="0"/>
              <a:t>12/10/22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119B71E5-87A7-6B66-00CB-DBE9FD3AAE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25A60DAC-1CF1-FB91-2A8B-FE3163455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FDA08-FEF8-4C4A-94DD-128D2DD817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338661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CA9CAAF-AC01-DA41-E2C0-66BB5C0A39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FFF6408-4742-514F-807E-91B293AF80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67F7944-2FB8-BDF1-C131-D844809D6C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2235ADB-A2FB-E8F6-386D-FA35CB019B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B7250-3C52-DD47-ABB0-447B6FB6FEBD}" type="datetimeFigureOut">
              <a:rPr lang="it-IT" smtClean="0"/>
              <a:t>12/10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3BE1E65-9527-C785-B2DC-8E99AF687B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339DDF0-D94F-8925-9FC1-25430E722B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FDA08-FEF8-4C4A-94DD-128D2DD817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99483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55D203C-509F-3DA0-B786-0D19145DB6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36272F66-3078-344C-D9FA-627AA038A0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E0DB9EB3-98BB-3858-D308-2BBA9B7EB8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8C71519-790A-3118-3E35-E3AD375A64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B7250-3C52-DD47-ABB0-447B6FB6FEBD}" type="datetimeFigureOut">
              <a:rPr lang="it-IT" smtClean="0"/>
              <a:t>12/10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DE7EF62-B377-B51A-5645-0FF18D4E13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E386F65-D412-AF23-F67F-CEAE69DD7F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FDA08-FEF8-4C4A-94DD-128D2DD817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98625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723308DB-E6D2-DA09-AF98-171708C3E8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C6069FF-34C6-9992-AEA4-1737533019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73864B5-0134-DE4F-CE76-F14177DC1D4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5B7250-3C52-DD47-ABB0-447B6FB6FEBD}" type="datetimeFigureOut">
              <a:rPr lang="it-IT" smtClean="0"/>
              <a:t>12/10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8A210EC-8F28-FE08-9062-9E636D2D940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A22580E-4BF3-261A-98F9-A8CC1347389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FFDA08-FEF8-4C4A-94DD-128D2DD817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055162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9DBD85AE-F9AE-3155-24DC-DE4679F281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891" y="742633"/>
            <a:ext cx="5359537" cy="2350537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35A905F1-620C-4859-58E0-01C07503149B}"/>
              </a:ext>
            </a:extLst>
          </p:cNvPr>
          <p:cNvSpPr txBox="1"/>
          <p:nvPr/>
        </p:nvSpPr>
        <p:spPr>
          <a:xfrm>
            <a:off x="1113539" y="357877"/>
            <a:ext cx="39522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b="1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Tuscia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Red apple flesh </a:t>
            </a:r>
            <a:r>
              <a:rPr lang="en-US" sz="1200" b="1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ompunds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detected at 520 nm</a:t>
            </a:r>
            <a:endParaRPr lang="it-IT" sz="1200" b="1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10" name="Immagine 9">
            <a:extLst>
              <a:ext uri="{FF2B5EF4-FFF2-40B4-BE49-F238E27FC236}">
                <a16:creationId xmlns:a16="http://schemas.microsoft.com/office/drawing/2014/main" id="{D36B1B83-B67A-630D-D656-50404445165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890" y="3764829"/>
            <a:ext cx="5359537" cy="2284858"/>
          </a:xfrm>
          <a:prstGeom prst="rect">
            <a:avLst/>
          </a:prstGeom>
          <a:noFill/>
          <a:ln>
            <a:noFill/>
          </a:ln>
        </p:spPr>
      </p:pic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930CD4CE-A760-AE04-C93E-139EC3BE0365}"/>
              </a:ext>
            </a:extLst>
          </p:cNvPr>
          <p:cNvSpPr txBox="1"/>
          <p:nvPr/>
        </p:nvSpPr>
        <p:spPr>
          <a:xfrm>
            <a:off x="1113539" y="3290500"/>
            <a:ext cx="39522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b="1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Annurca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apple flesh </a:t>
            </a:r>
            <a:r>
              <a:rPr lang="en-US" sz="1200" b="1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ompunds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detected at 520 nm</a:t>
            </a:r>
            <a:endParaRPr lang="it-IT" sz="1200" b="1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1D777DC3-6419-4468-73C8-E0915C6DAD82}"/>
              </a:ext>
            </a:extLst>
          </p:cNvPr>
          <p:cNvSpPr txBox="1"/>
          <p:nvPr/>
        </p:nvSpPr>
        <p:spPr>
          <a:xfrm>
            <a:off x="1372681" y="6247017"/>
            <a:ext cx="34339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>
                <a:latin typeface="Palatino Linotype" panose="02040502050505030304" pitchFamily="18" charset="0"/>
              </a:rPr>
              <a:t>HPLC </a:t>
            </a:r>
            <a:r>
              <a:rPr lang="it-IT" sz="1200" b="1" dirty="0" err="1">
                <a:latin typeface="Palatino Linotype" panose="02040502050505030304" pitchFamily="18" charset="0"/>
              </a:rPr>
              <a:t>detection</a:t>
            </a:r>
            <a:r>
              <a:rPr lang="it-IT" sz="1200" b="1" dirty="0">
                <a:latin typeface="Palatino Linotype" panose="02040502050505030304" pitchFamily="18" charset="0"/>
              </a:rPr>
              <a:t> of </a:t>
            </a:r>
            <a:r>
              <a:rPr lang="it-IT" sz="1200" b="1" dirty="0" err="1">
                <a:latin typeface="Palatino Linotype" panose="02040502050505030304" pitchFamily="18" charset="0"/>
              </a:rPr>
              <a:t>Anthocyanin</a:t>
            </a:r>
            <a:r>
              <a:rPr lang="it-IT" sz="1200" b="1" dirty="0">
                <a:latin typeface="Palatino Linotype" panose="02040502050505030304" pitchFamily="18" charset="0"/>
              </a:rPr>
              <a:t> </a:t>
            </a:r>
            <a:r>
              <a:rPr lang="it-IT" sz="1200" b="1" dirty="0" err="1">
                <a:latin typeface="Palatino Linotype" panose="02040502050505030304" pitchFamily="18" charset="0"/>
              </a:rPr>
              <a:t>at</a:t>
            </a:r>
            <a:r>
              <a:rPr lang="it-IT" sz="1200" b="1" dirty="0">
                <a:latin typeface="Palatino Linotype" panose="02040502050505030304" pitchFamily="18" charset="0"/>
              </a:rPr>
              <a:t> 520 nm</a:t>
            </a:r>
          </a:p>
          <a:p>
            <a:pPr algn="ctr"/>
            <a:r>
              <a:rPr lang="it-IT" sz="1200" b="1" dirty="0">
                <a:latin typeface="Palatino Linotype" panose="02040502050505030304" pitchFamily="18" charset="0"/>
              </a:rPr>
              <a:t>Note the </a:t>
            </a:r>
            <a:r>
              <a:rPr lang="it-IT" sz="1200" b="1" dirty="0" err="1">
                <a:latin typeface="Palatino Linotype" panose="02040502050505030304" pitchFamily="18" charset="0"/>
              </a:rPr>
              <a:t>absence</a:t>
            </a:r>
            <a:r>
              <a:rPr lang="it-IT" sz="1200" b="1" dirty="0">
                <a:latin typeface="Palatino Linotype" panose="02040502050505030304" pitchFamily="18" charset="0"/>
              </a:rPr>
              <a:t> of </a:t>
            </a:r>
            <a:r>
              <a:rPr lang="it-IT" sz="1200" b="1" dirty="0" err="1">
                <a:latin typeface="Palatino Linotype" panose="02040502050505030304" pitchFamily="18" charset="0"/>
              </a:rPr>
              <a:t>signal</a:t>
            </a:r>
            <a:r>
              <a:rPr lang="it-IT" sz="1200" b="1" dirty="0">
                <a:latin typeface="Palatino Linotype" panose="02040502050505030304" pitchFamily="18" charset="0"/>
              </a:rPr>
              <a:t> in Annurca </a:t>
            </a:r>
            <a:r>
              <a:rPr lang="it-IT" sz="1200" b="1" dirty="0" err="1">
                <a:latin typeface="Palatino Linotype" panose="02040502050505030304" pitchFamily="18" charset="0"/>
              </a:rPr>
              <a:t>extracts</a:t>
            </a:r>
            <a:endParaRPr lang="it-IT" sz="1200" b="1" dirty="0">
              <a:latin typeface="Palatino Linotype" panose="02040502050505030304" pitchFamily="18" charset="0"/>
            </a:endParaRP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636F6FBC-33B5-A31E-6447-6002EB6D631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09129" y="742633"/>
            <a:ext cx="5645978" cy="2342729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Immagine 3">
            <a:extLst>
              <a:ext uri="{FF2B5EF4-FFF2-40B4-BE49-F238E27FC236}">
                <a16:creationId xmlns:a16="http://schemas.microsoft.com/office/drawing/2014/main" id="{518805D0-B821-0E7C-31AC-68A39878710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15479" y="3764830"/>
            <a:ext cx="5639627" cy="2284858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6F5AC875-63E1-60FB-5EB2-29EDD2B92B50}"/>
              </a:ext>
            </a:extLst>
          </p:cNvPr>
          <p:cNvSpPr txBox="1"/>
          <p:nvPr/>
        </p:nvSpPr>
        <p:spPr>
          <a:xfrm>
            <a:off x="6755998" y="357876"/>
            <a:ext cx="39522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b="1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Tuscia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Red apple flesh </a:t>
            </a:r>
            <a:r>
              <a:rPr lang="en-US" sz="1200" b="1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ompunds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detected at 316 nm</a:t>
            </a:r>
            <a:endParaRPr lang="it-IT" sz="1200" b="1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69C2BA3D-C7E3-827E-4AE3-355D744FBF3B}"/>
              </a:ext>
            </a:extLst>
          </p:cNvPr>
          <p:cNvSpPr txBox="1"/>
          <p:nvPr/>
        </p:nvSpPr>
        <p:spPr>
          <a:xfrm>
            <a:off x="6755998" y="3290500"/>
            <a:ext cx="39522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 b="1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Annurca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apple flesh </a:t>
            </a:r>
            <a:r>
              <a:rPr lang="en-US" sz="1200" b="1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ompunds</a:t>
            </a:r>
            <a:r>
              <a:rPr lang="en-US" sz="12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detected at 316 nm</a:t>
            </a:r>
            <a:endParaRPr lang="it-IT" sz="1200" b="1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3C3E8790-A7ED-6DBA-2CDA-840EDE1465AA}"/>
              </a:ext>
            </a:extLst>
          </p:cNvPr>
          <p:cNvSpPr txBox="1"/>
          <p:nvPr/>
        </p:nvSpPr>
        <p:spPr>
          <a:xfrm>
            <a:off x="7000715" y="6339349"/>
            <a:ext cx="34628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>
                <a:latin typeface="Palatino Linotype" panose="02040502050505030304" pitchFamily="18" charset="0"/>
              </a:rPr>
              <a:t>HPLC </a:t>
            </a:r>
            <a:r>
              <a:rPr lang="it-IT" sz="1200" b="1" dirty="0" err="1">
                <a:latin typeface="Palatino Linotype" panose="02040502050505030304" pitchFamily="18" charset="0"/>
              </a:rPr>
              <a:t>detection</a:t>
            </a:r>
            <a:r>
              <a:rPr lang="it-IT" sz="1200" b="1" dirty="0">
                <a:latin typeface="Palatino Linotype" panose="02040502050505030304" pitchFamily="18" charset="0"/>
              </a:rPr>
              <a:t> of </a:t>
            </a:r>
            <a:r>
              <a:rPr lang="it-IT" sz="1200" b="1" dirty="0" err="1">
                <a:latin typeface="Palatino Linotype" panose="02040502050505030304" pitchFamily="18" charset="0"/>
              </a:rPr>
              <a:t>Chlorogenic</a:t>
            </a:r>
            <a:r>
              <a:rPr lang="it-IT" sz="1200" b="1" dirty="0">
                <a:latin typeface="Palatino Linotype" panose="02040502050505030304" pitchFamily="18" charset="0"/>
              </a:rPr>
              <a:t> Acid </a:t>
            </a:r>
            <a:r>
              <a:rPr lang="it-IT" sz="1200" b="1" dirty="0" err="1">
                <a:latin typeface="Palatino Linotype" panose="02040502050505030304" pitchFamily="18" charset="0"/>
              </a:rPr>
              <a:t>at</a:t>
            </a:r>
            <a:r>
              <a:rPr lang="it-IT" sz="1200" b="1" dirty="0">
                <a:latin typeface="Palatino Linotype" panose="02040502050505030304" pitchFamily="18" charset="0"/>
              </a:rPr>
              <a:t> 316 nm</a:t>
            </a:r>
          </a:p>
        </p:txBody>
      </p:sp>
    </p:spTree>
    <p:extLst>
      <p:ext uri="{BB962C8B-B14F-4D97-AF65-F5344CB8AC3E}">
        <p14:creationId xmlns:p14="http://schemas.microsoft.com/office/powerpoint/2010/main" val="412146697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57</Words>
  <Application>Microsoft Macintosh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orgio Prantera</dc:creator>
  <cp:lastModifiedBy>Giorgio Prantera</cp:lastModifiedBy>
  <cp:revision>6</cp:revision>
  <dcterms:created xsi:type="dcterms:W3CDTF">2022-10-11T18:01:14Z</dcterms:created>
  <dcterms:modified xsi:type="dcterms:W3CDTF">2022-10-12T07:28:56Z</dcterms:modified>
</cp:coreProperties>
</file>